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97" autoAdjust="0"/>
    <p:restoredTop sz="94660"/>
  </p:normalViewPr>
  <p:slideViewPr>
    <p:cSldViewPr snapToGrid="0">
      <p:cViewPr varScale="1">
        <p:scale>
          <a:sx n="85" d="100"/>
          <a:sy n="85" d="100"/>
        </p:scale>
        <p:origin x="45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55D518D-1C33-4390-80F8-461F32408CA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C323AAF3-2A59-425B-BD74-43941BB874A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F21BCCC9-557A-4915-9870-352CB0B37D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EDCC66-C3CC-4BEB-A614-928736938630}" type="datetimeFigureOut">
              <a:rPr lang="fr-FR" smtClean="0"/>
              <a:t>10/04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9BF426E6-55E8-4D7A-884E-C7B2AC4773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2561C32F-34AF-4EA1-9140-5EE4822578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F3F27F-094F-4EC6-AC0D-BEC8B97D470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769362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39A0731-3E57-4811-BA17-2107F40D0CF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89A74CF6-D3A8-4A8C-A18E-D947073955B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4C0E62C4-B6E6-4ED6-BD02-3D6E463AC5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EDCC66-C3CC-4BEB-A614-928736938630}" type="datetimeFigureOut">
              <a:rPr lang="fr-FR" smtClean="0"/>
              <a:t>10/04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534FF724-C721-441D-B8C7-65A3BD389A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0E106B6F-C3F1-4E09-AC09-4100EDA771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F3F27F-094F-4EC6-AC0D-BEC8B97D470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153904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C1D5D47F-1B42-4E1C-89F6-ED8AE4EA0DF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CAD511DF-02AB-4FC6-9851-7C2FB0E9267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72116DA9-CE7B-4B6B-AD85-A93038CAA5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EDCC66-C3CC-4BEB-A614-928736938630}" type="datetimeFigureOut">
              <a:rPr lang="fr-FR" smtClean="0"/>
              <a:t>10/04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A8226E0D-F32F-4760-8F06-510894F836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D971783E-EF6E-4331-A313-C7B2C86FDD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F3F27F-094F-4EC6-AC0D-BEC8B97D470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240169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9E1BCDD7-3785-4919-8E8F-E642BA646E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4C3B71A9-7CD2-487B-A701-F9F320CA6B0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3A0EC14D-6B31-4024-ABA2-99325F72F9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EDCC66-C3CC-4BEB-A614-928736938630}" type="datetimeFigureOut">
              <a:rPr lang="fr-FR" smtClean="0"/>
              <a:t>10/04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86F9B75B-9365-429D-918E-4000ACAC50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4730BA96-DDB7-4F22-BE05-1AD4F0AA4B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F3F27F-094F-4EC6-AC0D-BEC8B97D470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314321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942C82B4-BEC1-49E4-87E5-E6E12F7197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94934ACB-D56C-4E6B-A407-1F575C4BE4A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122B37F4-9FBC-4B64-839A-635BF502BD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EDCC66-C3CC-4BEB-A614-928736938630}" type="datetimeFigureOut">
              <a:rPr lang="fr-FR" smtClean="0"/>
              <a:t>10/04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49FCBFA6-0FC5-44AB-AD20-935D75FFA0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3EBBA103-1583-47A1-BB6A-0120EFDF4B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F3F27F-094F-4EC6-AC0D-BEC8B97D470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842975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C73C493-B17B-4F85-A934-548D4B8AF45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DCAB33FC-8B1D-4F62-A136-52F29B69F6D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8009CB6B-1AB4-48B8-A9F4-E99E8F78F47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2E355115-E5F3-4697-86E9-F528C72F81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EDCC66-C3CC-4BEB-A614-928736938630}" type="datetimeFigureOut">
              <a:rPr lang="fr-FR" smtClean="0"/>
              <a:t>10/04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BC344571-210F-4798-8B45-3CF6C1ECD6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9374B728-D2F2-4454-BC07-A9FEA6FD94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F3F27F-094F-4EC6-AC0D-BEC8B97D470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815288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BEE2D910-A646-4BFC-AFAF-73FE791789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E27ACA51-3929-4706-9A73-3C5623A5FA0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A66A0DF6-69CC-4C8D-A71C-8EDC1EC3454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B19D52BE-F12B-4C20-9836-51FD34B8117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8ECFA3E9-ED4E-4C3F-B357-64FF0EE4859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8CF77F6B-C271-4785-B884-103E358B88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EDCC66-C3CC-4BEB-A614-928736938630}" type="datetimeFigureOut">
              <a:rPr lang="fr-FR" smtClean="0"/>
              <a:t>10/04/2020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1F92DB84-04DD-4C08-8D81-8B0E522BDE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42B2F453-4E65-49F6-8E05-5D00AFB0B0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F3F27F-094F-4EC6-AC0D-BEC8B97D470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125396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838D0C1-1A10-48E8-890A-12D31584367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AF3F992E-CE7B-4B51-A7E3-C578C74CDC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EDCC66-C3CC-4BEB-A614-928736938630}" type="datetimeFigureOut">
              <a:rPr lang="fr-FR" smtClean="0"/>
              <a:t>10/04/2020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DF96FD73-4537-4652-B957-8A97529426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1036EDD3-74F2-47C3-918C-8105F6DDCE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F3F27F-094F-4EC6-AC0D-BEC8B97D470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640674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539ED961-52DE-45A4-B943-38CDE0763B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EDCC66-C3CC-4BEB-A614-928736938630}" type="datetimeFigureOut">
              <a:rPr lang="fr-FR" smtClean="0"/>
              <a:t>10/04/2020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B00EB98B-8210-4D58-8770-ED1B2AD2E3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2A9EE477-93D0-417D-82CA-D4D2785C78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F3F27F-094F-4EC6-AC0D-BEC8B97D470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97334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B55CB67-69B2-4297-9796-8E8BFCEC8C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C214783C-DED1-470A-9D84-8838A0F4B7F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0012D966-D729-44F1-BF89-3F587900986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3EB999BF-7800-47F1-8C41-5FE8CAD9A8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EDCC66-C3CC-4BEB-A614-928736938630}" type="datetimeFigureOut">
              <a:rPr lang="fr-FR" smtClean="0"/>
              <a:t>10/04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8D36B6B8-BE78-46F1-ADFD-9A08B4D65B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DC44BB24-247C-447F-A202-D0A0CCDB48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F3F27F-094F-4EC6-AC0D-BEC8B97D470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332620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B3D0591-0492-4FBB-A3CA-AB23B09474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33DCB3A7-E984-46C1-A52F-223D09E3A9A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FB987A63-BA36-4E51-B2F4-0C8A6B0C30B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50F3DC65-1F2A-4E87-8CB9-849C58EC85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EDCC66-C3CC-4BEB-A614-928736938630}" type="datetimeFigureOut">
              <a:rPr lang="fr-FR" smtClean="0"/>
              <a:t>10/04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020C69C1-1C79-486F-A14C-B04FFD1097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73C50DF0-89A5-4F58-AF0B-C65931AC08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F3F27F-094F-4EC6-AC0D-BEC8B97D470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884225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525F709C-99BE-45B7-8E68-F419B4383D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C0C25351-F11E-4C5B-BCC0-8C85F21B026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C9ED938A-7C58-4A95-A297-515C64B6861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EDCC66-C3CC-4BEB-A614-928736938630}" type="datetimeFigureOut">
              <a:rPr lang="fr-FR" smtClean="0"/>
              <a:t>10/04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A1B4B8E3-9D09-440A-B6BE-1728482175C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DF76687A-321B-4051-BB60-204CBE3B049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F3F27F-094F-4EC6-AC0D-BEC8B97D470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800933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>
            <a:extLst>
              <a:ext uri="{FF2B5EF4-FFF2-40B4-BE49-F238E27FC236}">
                <a16:creationId xmlns:a16="http://schemas.microsoft.com/office/drawing/2014/main" id="{3B5FC845-B63A-4BD8-BBFA-B9CE35487999}"/>
              </a:ext>
            </a:extLst>
          </p:cNvPr>
          <p:cNvSpPr/>
          <p:nvPr/>
        </p:nvSpPr>
        <p:spPr>
          <a:xfrm>
            <a:off x="549962" y="4109885"/>
            <a:ext cx="10185672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fr-FR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vitro</a:t>
            </a:r>
            <a:r>
              <a:rPr lang="fr-F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otease</a:t>
            </a:r>
            <a:r>
              <a:rPr lang="fr-F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ctivity</a:t>
            </a:r>
            <a:r>
              <a:rPr lang="fr-F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fr-FR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. </a:t>
            </a:r>
            <a:r>
              <a:rPr lang="fr-FR" sz="14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olixus</a:t>
            </a:r>
            <a:r>
              <a:rPr lang="fr-FR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M </a:t>
            </a:r>
            <a:r>
              <a:rPr lang="fr-FR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xtracts</a:t>
            </a:r>
            <a:r>
              <a:rPr lang="fr-F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6 h </a:t>
            </a:r>
            <a:r>
              <a:rPr lang="fr-FR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fter</a:t>
            </a:r>
            <a:r>
              <a:rPr lang="fr-F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lood</a:t>
            </a:r>
            <a:r>
              <a:rPr lang="fr-F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eeding</a:t>
            </a:r>
            <a:r>
              <a:rPr lang="fr-F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t </a:t>
            </a:r>
            <a:r>
              <a:rPr lang="fr-FR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cidic</a:t>
            </a:r>
            <a:r>
              <a:rPr lang="fr-F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neutral pH.</a:t>
            </a:r>
            <a:endParaRPr lang="fr-F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fr-F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fr-F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ctivity</a:t>
            </a:r>
            <a:r>
              <a:rPr lang="fr-F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as</a:t>
            </a:r>
            <a:r>
              <a:rPr lang="fr-F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ssayed</a:t>
            </a:r>
            <a:r>
              <a:rPr lang="fr-F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t pH 5.2 and pH 7 </a:t>
            </a:r>
            <a:r>
              <a:rPr lang="fr-F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fr-F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M </a:t>
            </a:r>
            <a:r>
              <a:rPr lang="fr-F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xtracts</a:t>
            </a:r>
            <a:r>
              <a:rPr lang="fr-F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6 h </a:t>
            </a:r>
            <a:r>
              <a:rPr lang="fr-F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fter</a:t>
            </a:r>
            <a:r>
              <a:rPr lang="fr-F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lood</a:t>
            </a:r>
            <a:r>
              <a:rPr lang="fr-F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eeding</a:t>
            </a:r>
            <a:r>
              <a:rPr lang="fr-F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fr-F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sing</a:t>
            </a:r>
            <a:r>
              <a:rPr lang="fr-F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zocasin</a:t>
            </a:r>
            <a:r>
              <a:rPr lang="fr-F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s </a:t>
            </a:r>
            <a:r>
              <a:rPr lang="fr-F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bstrate</a:t>
            </a:r>
            <a:r>
              <a:rPr lang="fr-F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Activity </a:t>
            </a:r>
            <a:r>
              <a:rPr lang="fr-F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as</a:t>
            </a:r>
            <a:r>
              <a:rPr lang="fr-F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lso</a:t>
            </a:r>
            <a:r>
              <a:rPr lang="fr-F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asured</a:t>
            </a:r>
            <a:r>
              <a:rPr lang="fr-F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the </a:t>
            </a:r>
            <a:r>
              <a:rPr lang="fr-F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esence</a:t>
            </a:r>
            <a:r>
              <a:rPr lang="fr-F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fr-F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epstatin</a:t>
            </a:r>
            <a:r>
              <a:rPr lang="fr-F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, a </a:t>
            </a:r>
            <a:r>
              <a:rPr lang="fr-F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pecific</a:t>
            </a:r>
            <a:r>
              <a:rPr lang="fr-F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spartic</a:t>
            </a:r>
            <a:r>
              <a:rPr lang="fr-F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otease</a:t>
            </a:r>
            <a:r>
              <a:rPr lang="fr-F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hibitor</a:t>
            </a:r>
            <a:r>
              <a:rPr lang="fr-F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The </a:t>
            </a:r>
            <a:r>
              <a:rPr lang="fr-F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hibitory</a:t>
            </a:r>
            <a:r>
              <a:rPr lang="fr-F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ffect</a:t>
            </a:r>
            <a:r>
              <a:rPr lang="fr-F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as</a:t>
            </a:r>
            <a:r>
              <a:rPr lang="fr-F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ot total at pH 7 </a:t>
            </a:r>
            <a:r>
              <a:rPr lang="fr-F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cause</a:t>
            </a:r>
            <a:r>
              <a:rPr lang="fr-F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epstatin</a:t>
            </a:r>
            <a:r>
              <a:rPr lang="fr-F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s</a:t>
            </a:r>
            <a:r>
              <a:rPr lang="fr-F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soluble </a:t>
            </a:r>
            <a:r>
              <a:rPr lang="fr-F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ear</a:t>
            </a:r>
            <a:r>
              <a:rPr lang="fr-F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eutral pH as </a:t>
            </a:r>
            <a:r>
              <a:rPr lang="fr-F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dicated</a:t>
            </a:r>
            <a:r>
              <a:rPr lang="fr-F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y the </a:t>
            </a:r>
            <a:r>
              <a:rPr lang="fr-F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endor</a:t>
            </a:r>
            <a:r>
              <a:rPr lang="fr-F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One unit of </a:t>
            </a:r>
            <a:r>
              <a:rPr lang="fr-F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ctivity</a:t>
            </a:r>
            <a:r>
              <a:rPr lang="fr-F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rresponds to absorbance </a:t>
            </a:r>
            <a:r>
              <a:rPr lang="fr-F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crease</a:t>
            </a:r>
            <a:r>
              <a:rPr lang="fr-F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0,001. </a:t>
            </a:r>
          </a:p>
        </p:txBody>
      </p:sp>
      <p:pic>
        <p:nvPicPr>
          <p:cNvPr id="8" name="Image 7" descr="Une image contenant horloge&#10;&#10;Description générée automatiquement">
            <a:extLst>
              <a:ext uri="{FF2B5EF4-FFF2-40B4-BE49-F238E27FC236}">
                <a16:creationId xmlns:a16="http://schemas.microsoft.com/office/drawing/2014/main" id="{EBA1F3CB-AFE6-4B1C-AFA4-E575B8865B5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97591" y="421485"/>
            <a:ext cx="4176122" cy="3688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78655252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0</TotalTime>
  <Words>95</Words>
  <Application>Microsoft Office PowerPoint</Application>
  <PresentationFormat>Grand écran</PresentationFormat>
  <Paragraphs>2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redouane ouali</dc:creator>
  <cp:lastModifiedBy>Sabrina BOUSBATA</cp:lastModifiedBy>
  <cp:revision>11</cp:revision>
  <dcterms:created xsi:type="dcterms:W3CDTF">2020-04-10T12:33:12Z</dcterms:created>
  <dcterms:modified xsi:type="dcterms:W3CDTF">2020-04-10T15:37:18Z</dcterms:modified>
</cp:coreProperties>
</file>